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87" r:id="rId2"/>
    <p:sldId id="285" r:id="rId3"/>
    <p:sldId id="265" r:id="rId4"/>
    <p:sldId id="268" r:id="rId5"/>
    <p:sldId id="271" r:id="rId6"/>
    <p:sldId id="275" r:id="rId7"/>
    <p:sldId id="276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79FA100-3C13-D998-6321-3940A1901154}" name="WILTON MBINDA" initials="WM" userId="2ed3b63821f91397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40" autoAdjust="0"/>
    <p:restoredTop sz="94660"/>
  </p:normalViewPr>
  <p:slideViewPr>
    <p:cSldViewPr snapToGrid="0">
      <p:cViewPr varScale="1">
        <p:scale>
          <a:sx n="64" d="100"/>
          <a:sy n="64" d="100"/>
        </p:scale>
        <p:origin x="67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ILTON MBINDA" userId="2ed3b63821f91397" providerId="LiveId" clId="{F32CC61D-BA29-4110-8792-445E93117010}"/>
    <pc:docChg chg="modSld">
      <pc:chgData name="WILTON MBINDA" userId="2ed3b63821f91397" providerId="LiveId" clId="{F32CC61D-BA29-4110-8792-445E93117010}" dt="2024-05-25T06:42:51.434" v="4" actId="20577"/>
      <pc:docMkLst>
        <pc:docMk/>
      </pc:docMkLst>
      <pc:sldChg chg="modSp mod">
        <pc:chgData name="WILTON MBINDA" userId="2ed3b63821f91397" providerId="LiveId" clId="{F32CC61D-BA29-4110-8792-445E93117010}" dt="2024-05-25T06:42:51.434" v="4" actId="20577"/>
        <pc:sldMkLst>
          <pc:docMk/>
          <pc:sldMk cId="1063070901" sldId="287"/>
        </pc:sldMkLst>
        <pc:spChg chg="mod">
          <ac:chgData name="WILTON MBINDA" userId="2ed3b63821f91397" providerId="LiveId" clId="{F32CC61D-BA29-4110-8792-445E93117010}" dt="2024-05-25T06:42:51.434" v="4" actId="20577"/>
          <ac:spMkLst>
            <pc:docMk/>
            <pc:sldMk cId="1063070901" sldId="287"/>
            <ac:spMk id="4" creationId="{00000000-0000-0000-0000-000000000000}"/>
          </ac:spMkLst>
        </pc:spChg>
      </pc:sldChg>
    </pc:docChg>
  </pc:docChgLst>
  <pc:docChgLst>
    <pc:chgData name="WILTON MBINDA" userId="2ed3b63821f91397" providerId="LiveId" clId="{C0CC7D25-D4DE-48FC-9E79-E0D5A3969793}"/>
    <pc:docChg chg="custSel modSld">
      <pc:chgData name="WILTON MBINDA" userId="2ed3b63821f91397" providerId="LiveId" clId="{C0CC7D25-D4DE-48FC-9E79-E0D5A3969793}" dt="2023-11-21T07:52:02.359" v="52"/>
      <pc:docMkLst>
        <pc:docMk/>
      </pc:docMkLst>
      <pc:sldChg chg="modSp mod">
        <pc:chgData name="WILTON MBINDA" userId="2ed3b63821f91397" providerId="LiveId" clId="{C0CC7D25-D4DE-48FC-9E79-E0D5A3969793}" dt="2023-11-21T07:51:01.027" v="41" actId="20577"/>
        <pc:sldMkLst>
          <pc:docMk/>
          <pc:sldMk cId="322960254" sldId="265"/>
        </pc:sldMkLst>
        <pc:spChg chg="mod">
          <ac:chgData name="WILTON MBINDA" userId="2ed3b63821f91397" providerId="LiveId" clId="{C0CC7D25-D4DE-48FC-9E79-E0D5A3969793}" dt="2023-11-21T07:51:01.027" v="41" actId="20577"/>
          <ac:spMkLst>
            <pc:docMk/>
            <pc:sldMk cId="322960254" sldId="265"/>
            <ac:spMk id="12" creationId="{00000000-0000-0000-0000-000000000000}"/>
          </ac:spMkLst>
        </pc:spChg>
      </pc:sldChg>
      <pc:sldChg chg="modSp mod">
        <pc:chgData name="WILTON MBINDA" userId="2ed3b63821f91397" providerId="LiveId" clId="{C0CC7D25-D4DE-48FC-9E79-E0D5A3969793}" dt="2023-11-21T07:51:05.542" v="43" actId="20577"/>
        <pc:sldMkLst>
          <pc:docMk/>
          <pc:sldMk cId="2892551273" sldId="270"/>
        </pc:sldMkLst>
        <pc:spChg chg="mod">
          <ac:chgData name="WILTON MBINDA" userId="2ed3b63821f91397" providerId="LiveId" clId="{C0CC7D25-D4DE-48FC-9E79-E0D5A3969793}" dt="2023-11-21T07:51:05.542" v="43" actId="20577"/>
          <ac:spMkLst>
            <pc:docMk/>
            <pc:sldMk cId="2892551273" sldId="270"/>
            <ac:spMk id="7" creationId="{00000000-0000-0000-0000-000000000000}"/>
          </ac:spMkLst>
        </pc:spChg>
      </pc:sldChg>
      <pc:sldChg chg="modSp mod">
        <pc:chgData name="WILTON MBINDA" userId="2ed3b63821f91397" providerId="LiveId" clId="{C0CC7D25-D4DE-48FC-9E79-E0D5A3969793}" dt="2023-11-21T07:51:10.476" v="45" actId="20577"/>
        <pc:sldMkLst>
          <pc:docMk/>
          <pc:sldMk cId="1608119596" sldId="271"/>
        </pc:sldMkLst>
        <pc:spChg chg="mod">
          <ac:chgData name="WILTON MBINDA" userId="2ed3b63821f91397" providerId="LiveId" clId="{C0CC7D25-D4DE-48FC-9E79-E0D5A3969793}" dt="2023-11-21T07:51:10.476" v="45" actId="20577"/>
          <ac:spMkLst>
            <pc:docMk/>
            <pc:sldMk cId="1608119596" sldId="271"/>
            <ac:spMk id="3" creationId="{00000000-0000-0000-0000-000000000000}"/>
          </ac:spMkLst>
        </pc:spChg>
      </pc:sldChg>
      <pc:sldChg chg="modSp mod delCm modCm">
        <pc:chgData name="WILTON MBINDA" userId="2ed3b63821f91397" providerId="LiveId" clId="{C0CC7D25-D4DE-48FC-9E79-E0D5A3969793}" dt="2023-11-21T07:52:02.359" v="52"/>
        <pc:sldMkLst>
          <pc:docMk/>
          <pc:sldMk cId="813699893" sldId="275"/>
        </pc:sldMkLst>
        <pc:spChg chg="mod">
          <ac:chgData name="WILTON MBINDA" userId="2ed3b63821f91397" providerId="LiveId" clId="{C0CC7D25-D4DE-48FC-9E79-E0D5A3969793}" dt="2023-11-21T07:51:24.374" v="47" actId="20577"/>
          <ac:spMkLst>
            <pc:docMk/>
            <pc:sldMk cId="813699893" sldId="275"/>
            <ac:spMk id="3" creationId="{00000000-0000-0000-0000-000000000000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chg="del mod">
              <pc226:chgData name="WILTON MBINDA" userId="2ed3b63821f91397" providerId="LiveId" clId="{C0CC7D25-D4DE-48FC-9E79-E0D5A3969793}" dt="2023-11-21T07:52:02.359" v="52"/>
              <pc2:cmMkLst xmlns:pc2="http://schemas.microsoft.com/office/powerpoint/2019/9/main/command">
                <pc:docMk/>
                <pc:sldMk cId="813699893" sldId="275"/>
                <pc2:cmMk id="{4D484146-07E8-4BEE-A6B6-C40E90F838AD}"/>
              </pc2:cmMkLst>
            </pc226:cmChg>
          </p:ext>
        </pc:extLst>
      </pc:sldChg>
      <pc:sldChg chg="modSp mod delCm modCm">
        <pc:chgData name="WILTON MBINDA" userId="2ed3b63821f91397" providerId="LiveId" clId="{C0CC7D25-D4DE-48FC-9E79-E0D5A3969793}" dt="2023-11-21T07:51:43.744" v="51"/>
        <pc:sldMkLst>
          <pc:docMk/>
          <pc:sldMk cId="3113638548" sldId="276"/>
        </pc:sldMkLst>
        <pc:spChg chg="mod">
          <ac:chgData name="WILTON MBINDA" userId="2ed3b63821f91397" providerId="LiveId" clId="{C0CC7D25-D4DE-48FC-9E79-E0D5A3969793}" dt="2023-11-21T07:51:29.585" v="49" actId="20577"/>
          <ac:spMkLst>
            <pc:docMk/>
            <pc:sldMk cId="3113638548" sldId="276"/>
            <ac:spMk id="3" creationId="{00000000-0000-0000-0000-000000000000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chg="del mod">
              <pc226:chgData name="WILTON MBINDA" userId="2ed3b63821f91397" providerId="LiveId" clId="{C0CC7D25-D4DE-48FC-9E79-E0D5A3969793}" dt="2023-11-21T07:51:43.744" v="51"/>
              <pc2:cmMkLst xmlns:pc2="http://schemas.microsoft.com/office/powerpoint/2019/9/main/command">
                <pc:docMk/>
                <pc:sldMk cId="3113638548" sldId="276"/>
                <pc2:cmMk id="{04B088E7-FA5E-43A3-9FD8-7316F437F86E}"/>
              </pc2:cmMkLst>
            </pc226:cmChg>
          </p:ext>
        </pc:extLst>
      </pc:sldChg>
      <pc:sldChg chg="modSp mod">
        <pc:chgData name="WILTON MBINDA" userId="2ed3b63821f91397" providerId="LiveId" clId="{C0CC7D25-D4DE-48FC-9E79-E0D5A3969793}" dt="2023-11-21T07:50:55.772" v="39" actId="20577"/>
        <pc:sldMkLst>
          <pc:docMk/>
          <pc:sldMk cId="1224104333" sldId="285"/>
        </pc:sldMkLst>
        <pc:spChg chg="mod">
          <ac:chgData name="WILTON MBINDA" userId="2ed3b63821f91397" providerId="LiveId" clId="{C0CC7D25-D4DE-48FC-9E79-E0D5A3969793}" dt="2023-11-21T07:50:55.772" v="39" actId="20577"/>
          <ac:spMkLst>
            <pc:docMk/>
            <pc:sldMk cId="1224104333" sldId="285"/>
            <ac:spMk id="7" creationId="{00000000-0000-0000-0000-000000000000}"/>
          </ac:spMkLst>
        </pc:spChg>
      </pc:sldChg>
    </pc:docChg>
  </pc:docChgLst>
  <pc:docChgLst>
    <pc:chgData name="WILTON MBINDA" userId="2ed3b63821f91397" providerId="LiveId" clId="{0A6442AD-8706-4623-A6F7-D8DA1AE96F48}"/>
    <pc:docChg chg="modSld">
      <pc:chgData name="WILTON MBINDA" userId="2ed3b63821f91397" providerId="LiveId" clId="{0A6442AD-8706-4623-A6F7-D8DA1AE96F48}" dt="2024-06-06T08:49:39.148" v="19" actId="20577"/>
      <pc:docMkLst>
        <pc:docMk/>
      </pc:docMkLst>
      <pc:sldChg chg="modSp mod">
        <pc:chgData name="WILTON MBINDA" userId="2ed3b63821f91397" providerId="LiveId" clId="{0A6442AD-8706-4623-A6F7-D8DA1AE96F48}" dt="2024-06-06T08:49:17.805" v="15" actId="20577"/>
        <pc:sldMkLst>
          <pc:docMk/>
          <pc:sldMk cId="322960254" sldId="265"/>
        </pc:sldMkLst>
        <pc:spChg chg="mod">
          <ac:chgData name="WILTON MBINDA" userId="2ed3b63821f91397" providerId="LiveId" clId="{0A6442AD-8706-4623-A6F7-D8DA1AE96F48}" dt="2024-06-06T08:49:17.805" v="15" actId="20577"/>
          <ac:spMkLst>
            <pc:docMk/>
            <pc:sldMk cId="322960254" sldId="265"/>
            <ac:spMk id="12" creationId="{00000000-0000-0000-0000-000000000000}"/>
          </ac:spMkLst>
        </pc:spChg>
      </pc:sldChg>
      <pc:sldChg chg="modSp mod">
        <pc:chgData name="WILTON MBINDA" userId="2ed3b63821f91397" providerId="LiveId" clId="{0A6442AD-8706-4623-A6F7-D8DA1AE96F48}" dt="2024-06-06T08:49:24.223" v="16" actId="20577"/>
        <pc:sldMkLst>
          <pc:docMk/>
          <pc:sldMk cId="2923045384" sldId="268"/>
        </pc:sldMkLst>
        <pc:spChg chg="mod">
          <ac:chgData name="WILTON MBINDA" userId="2ed3b63821f91397" providerId="LiveId" clId="{0A6442AD-8706-4623-A6F7-D8DA1AE96F48}" dt="2024-06-06T08:49:24.223" v="16" actId="20577"/>
          <ac:spMkLst>
            <pc:docMk/>
            <pc:sldMk cId="2923045384" sldId="268"/>
            <ac:spMk id="5" creationId="{28F699B2-A32F-3FAB-A42C-E6480C680EA6}"/>
          </ac:spMkLst>
        </pc:spChg>
      </pc:sldChg>
      <pc:sldChg chg="modSp mod">
        <pc:chgData name="WILTON MBINDA" userId="2ed3b63821f91397" providerId="LiveId" clId="{0A6442AD-8706-4623-A6F7-D8DA1AE96F48}" dt="2024-06-06T08:49:30.249" v="17" actId="20577"/>
        <pc:sldMkLst>
          <pc:docMk/>
          <pc:sldMk cId="1608119596" sldId="271"/>
        </pc:sldMkLst>
        <pc:spChg chg="mod">
          <ac:chgData name="WILTON MBINDA" userId="2ed3b63821f91397" providerId="LiveId" clId="{0A6442AD-8706-4623-A6F7-D8DA1AE96F48}" dt="2024-06-06T08:49:30.249" v="17" actId="20577"/>
          <ac:spMkLst>
            <pc:docMk/>
            <pc:sldMk cId="1608119596" sldId="271"/>
            <ac:spMk id="3" creationId="{00000000-0000-0000-0000-000000000000}"/>
          </ac:spMkLst>
        </pc:spChg>
      </pc:sldChg>
      <pc:sldChg chg="modSp mod">
        <pc:chgData name="WILTON MBINDA" userId="2ed3b63821f91397" providerId="LiveId" clId="{0A6442AD-8706-4623-A6F7-D8DA1AE96F48}" dt="2024-06-06T08:49:34.058" v="18" actId="20577"/>
        <pc:sldMkLst>
          <pc:docMk/>
          <pc:sldMk cId="813699893" sldId="275"/>
        </pc:sldMkLst>
        <pc:spChg chg="mod">
          <ac:chgData name="WILTON MBINDA" userId="2ed3b63821f91397" providerId="LiveId" clId="{0A6442AD-8706-4623-A6F7-D8DA1AE96F48}" dt="2024-06-06T08:49:34.058" v="18" actId="20577"/>
          <ac:spMkLst>
            <pc:docMk/>
            <pc:sldMk cId="813699893" sldId="275"/>
            <ac:spMk id="3" creationId="{00000000-0000-0000-0000-000000000000}"/>
          </ac:spMkLst>
        </pc:spChg>
      </pc:sldChg>
      <pc:sldChg chg="modSp mod">
        <pc:chgData name="WILTON MBINDA" userId="2ed3b63821f91397" providerId="LiveId" clId="{0A6442AD-8706-4623-A6F7-D8DA1AE96F48}" dt="2024-06-06T08:49:39.148" v="19" actId="20577"/>
        <pc:sldMkLst>
          <pc:docMk/>
          <pc:sldMk cId="3113638548" sldId="276"/>
        </pc:sldMkLst>
        <pc:spChg chg="mod">
          <ac:chgData name="WILTON MBINDA" userId="2ed3b63821f91397" providerId="LiveId" clId="{0A6442AD-8706-4623-A6F7-D8DA1AE96F48}" dt="2024-06-06T08:49:39.148" v="19" actId="20577"/>
          <ac:spMkLst>
            <pc:docMk/>
            <pc:sldMk cId="3113638548" sldId="276"/>
            <ac:spMk id="3" creationId="{00000000-0000-0000-0000-000000000000}"/>
          </ac:spMkLst>
        </pc:spChg>
      </pc:sldChg>
      <pc:sldChg chg="modSp mod">
        <pc:chgData name="WILTON MBINDA" userId="2ed3b63821f91397" providerId="LiveId" clId="{0A6442AD-8706-4623-A6F7-D8DA1AE96F48}" dt="2024-06-06T08:49:14.006" v="14" actId="20577"/>
        <pc:sldMkLst>
          <pc:docMk/>
          <pc:sldMk cId="1224104333" sldId="285"/>
        </pc:sldMkLst>
        <pc:spChg chg="mod">
          <ac:chgData name="WILTON MBINDA" userId="2ed3b63821f91397" providerId="LiveId" clId="{0A6442AD-8706-4623-A6F7-D8DA1AE96F48}" dt="2024-06-06T08:49:14.006" v="14" actId="20577"/>
          <ac:spMkLst>
            <pc:docMk/>
            <pc:sldMk cId="1224104333" sldId="285"/>
            <ac:spMk id="7" creationId="{00000000-0000-0000-0000-000000000000}"/>
          </ac:spMkLst>
        </pc:spChg>
      </pc:sldChg>
      <pc:sldChg chg="modSp mod">
        <pc:chgData name="WILTON MBINDA" userId="2ed3b63821f91397" providerId="LiveId" clId="{0A6442AD-8706-4623-A6F7-D8DA1AE96F48}" dt="2024-06-06T08:19:19.696" v="13" actId="14734"/>
        <pc:sldMkLst>
          <pc:docMk/>
          <pc:sldMk cId="1063070901" sldId="287"/>
        </pc:sldMkLst>
        <pc:graphicFrameChg chg="mod modGraphic">
          <ac:chgData name="WILTON MBINDA" userId="2ed3b63821f91397" providerId="LiveId" clId="{0A6442AD-8706-4623-A6F7-D8DA1AE96F48}" dt="2024-06-06T08:19:19.696" v="13" actId="14734"/>
          <ac:graphicFrameMkLst>
            <pc:docMk/>
            <pc:sldMk cId="1063070901" sldId="287"/>
            <ac:graphicFrameMk id="5" creationId="{00000000-0000-0000-0000-000000000000}"/>
          </ac:graphicFrameMkLst>
        </pc:graphicFrameChg>
      </pc:sldChg>
    </pc:docChg>
  </pc:docChgLst>
  <pc:docChgLst>
    <pc:chgData name="WILTON MBINDA" userId="2ed3b63821f91397" providerId="LiveId" clId="{321BA248-EF86-438F-BB9D-92D1FC92C99F}"/>
    <pc:docChg chg="modSld">
      <pc:chgData name="WILTON MBINDA" userId="2ed3b63821f91397" providerId="LiveId" clId="{321BA248-EF86-438F-BB9D-92D1FC92C99F}" dt="2023-11-04T13:46:04.900" v="59"/>
      <pc:docMkLst>
        <pc:docMk/>
      </pc:docMkLst>
      <pc:sldChg chg="modSp mod">
        <pc:chgData name="WILTON MBINDA" userId="2ed3b63821f91397" providerId="LiveId" clId="{321BA248-EF86-438F-BB9D-92D1FC92C99F}" dt="2023-11-04T13:45:15.420" v="55" actId="20577"/>
        <pc:sldMkLst>
          <pc:docMk/>
          <pc:sldMk cId="322960254" sldId="265"/>
        </pc:sldMkLst>
        <pc:spChg chg="mod">
          <ac:chgData name="WILTON MBINDA" userId="2ed3b63821f91397" providerId="LiveId" clId="{321BA248-EF86-438F-BB9D-92D1FC92C99F}" dt="2023-11-04T13:45:15.420" v="55" actId="20577"/>
          <ac:spMkLst>
            <pc:docMk/>
            <pc:sldMk cId="322960254" sldId="265"/>
            <ac:spMk id="12" creationId="{00000000-0000-0000-0000-000000000000}"/>
          </ac:spMkLst>
        </pc:spChg>
      </pc:sldChg>
      <pc:sldChg chg="modSp mod">
        <pc:chgData name="WILTON MBINDA" userId="2ed3b63821f91397" providerId="LiveId" clId="{321BA248-EF86-438F-BB9D-92D1FC92C99F}" dt="2023-11-04T13:28:36.511" v="16" actId="113"/>
        <pc:sldMkLst>
          <pc:docMk/>
          <pc:sldMk cId="2892551273" sldId="270"/>
        </pc:sldMkLst>
        <pc:spChg chg="mod">
          <ac:chgData name="WILTON MBINDA" userId="2ed3b63821f91397" providerId="LiveId" clId="{321BA248-EF86-438F-BB9D-92D1FC92C99F}" dt="2023-11-04T13:28:36.511" v="16" actId="113"/>
          <ac:spMkLst>
            <pc:docMk/>
            <pc:sldMk cId="2892551273" sldId="270"/>
            <ac:spMk id="7" creationId="{00000000-0000-0000-0000-000000000000}"/>
          </ac:spMkLst>
        </pc:spChg>
      </pc:sldChg>
      <pc:sldChg chg="modSp mod">
        <pc:chgData name="WILTON MBINDA" userId="2ed3b63821f91397" providerId="LiveId" clId="{321BA248-EF86-438F-BB9D-92D1FC92C99F}" dt="2023-11-04T13:30:01.010" v="32" actId="2710"/>
        <pc:sldMkLst>
          <pc:docMk/>
          <pc:sldMk cId="1608119596" sldId="271"/>
        </pc:sldMkLst>
        <pc:spChg chg="mod">
          <ac:chgData name="WILTON MBINDA" userId="2ed3b63821f91397" providerId="LiveId" clId="{321BA248-EF86-438F-BB9D-92D1FC92C99F}" dt="2023-11-04T13:30:01.010" v="32" actId="2710"/>
          <ac:spMkLst>
            <pc:docMk/>
            <pc:sldMk cId="1608119596" sldId="271"/>
            <ac:spMk id="3" creationId="{00000000-0000-0000-0000-000000000000}"/>
          </ac:spMkLst>
        </pc:spChg>
      </pc:sldChg>
      <pc:sldChg chg="modSp mod addCm modCm">
        <pc:chgData name="WILTON MBINDA" userId="2ed3b63821f91397" providerId="LiveId" clId="{321BA248-EF86-438F-BB9D-92D1FC92C99F}" dt="2023-11-04T13:44:59.219" v="53" actId="20577"/>
        <pc:sldMkLst>
          <pc:docMk/>
          <pc:sldMk cId="2271441161" sldId="273"/>
        </pc:sldMkLst>
        <pc:spChg chg="mod">
          <ac:chgData name="WILTON MBINDA" userId="2ed3b63821f91397" providerId="LiveId" clId="{321BA248-EF86-438F-BB9D-92D1FC92C99F}" dt="2023-11-04T13:44:59.219" v="53" actId="20577"/>
          <ac:spMkLst>
            <pc:docMk/>
            <pc:sldMk cId="2271441161" sldId="273"/>
            <ac:spMk id="7" creationId="{00000000-0000-0000-0000-000000000000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chg="add mod">
              <pc226:chgData name="WILTON MBINDA" userId="2ed3b63821f91397" providerId="LiveId" clId="{321BA248-EF86-438F-BB9D-92D1FC92C99F}" dt="2023-11-04T13:44:59.219" v="53" actId="20577"/>
              <pc2:cmMkLst xmlns:pc2="http://schemas.microsoft.com/office/powerpoint/2019/9/main/command">
                <pc:docMk/>
                <pc:sldMk cId="2271441161" sldId="273"/>
                <pc2:cmMk id="{62848BB0-5A45-4F43-BDF4-32899DA6977B}"/>
              </pc2:cmMkLst>
            </pc226:cmChg>
          </p:ext>
        </pc:extLst>
      </pc:sldChg>
      <pc:sldChg chg="modSp mod addCm">
        <pc:chgData name="WILTON MBINDA" userId="2ed3b63821f91397" providerId="LiveId" clId="{321BA248-EF86-438F-BB9D-92D1FC92C99F}" dt="2023-11-04T13:46:04.900" v="59"/>
        <pc:sldMkLst>
          <pc:docMk/>
          <pc:sldMk cId="813699893" sldId="275"/>
        </pc:sldMkLst>
        <pc:spChg chg="mod">
          <ac:chgData name="WILTON MBINDA" userId="2ed3b63821f91397" providerId="LiveId" clId="{321BA248-EF86-438F-BB9D-92D1FC92C99F}" dt="2023-11-04T13:45:44.639" v="58" actId="6549"/>
          <ac:spMkLst>
            <pc:docMk/>
            <pc:sldMk cId="813699893" sldId="275"/>
            <ac:spMk id="3" creationId="{00000000-0000-0000-0000-000000000000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chg="add">
              <pc226:chgData name="WILTON MBINDA" userId="2ed3b63821f91397" providerId="LiveId" clId="{321BA248-EF86-438F-BB9D-92D1FC92C99F}" dt="2023-11-04T13:46:04.900" v="59"/>
              <pc2:cmMkLst xmlns:pc2="http://schemas.microsoft.com/office/powerpoint/2019/9/main/command">
                <pc:docMk/>
                <pc:sldMk cId="813699893" sldId="275"/>
                <pc2:cmMk id="{4D484146-07E8-4BEE-A6B6-C40E90F838AD}"/>
              </pc2:cmMkLst>
            </pc226:cmChg>
          </p:ext>
        </pc:extLst>
      </pc:sldChg>
      <pc:sldChg chg="modSp mod addCm">
        <pc:chgData name="WILTON MBINDA" userId="2ed3b63821f91397" providerId="LiveId" clId="{321BA248-EF86-438F-BB9D-92D1FC92C99F}" dt="2023-11-04T13:41:50.802" v="43"/>
        <pc:sldMkLst>
          <pc:docMk/>
          <pc:sldMk cId="3113638548" sldId="276"/>
        </pc:sldMkLst>
        <pc:spChg chg="mod">
          <ac:chgData name="WILTON MBINDA" userId="2ed3b63821f91397" providerId="LiveId" clId="{321BA248-EF86-438F-BB9D-92D1FC92C99F}" dt="2023-11-04T13:41:23.874" v="42" actId="114"/>
          <ac:spMkLst>
            <pc:docMk/>
            <pc:sldMk cId="3113638548" sldId="276"/>
            <ac:spMk id="3" creationId="{00000000-0000-0000-0000-000000000000}"/>
          </ac:spMkLst>
        </pc:spChg>
        <pc:extLst>
          <p:ext xmlns:p="http://schemas.openxmlformats.org/presentationml/2006/main" uri="{D6D511B9-2390-475A-947B-AFAB55BFBCF1}">
            <pc226:cmChg xmlns:pc226="http://schemas.microsoft.com/office/powerpoint/2022/06/main/command" chg="add">
              <pc226:chgData name="WILTON MBINDA" userId="2ed3b63821f91397" providerId="LiveId" clId="{321BA248-EF86-438F-BB9D-92D1FC92C99F}" dt="2023-11-04T13:41:50.802" v="43"/>
              <pc2:cmMkLst xmlns:pc2="http://schemas.microsoft.com/office/powerpoint/2019/9/main/command">
                <pc:docMk/>
                <pc:sldMk cId="3113638548" sldId="276"/>
                <pc2:cmMk id="{04B088E7-FA5E-43A3-9FD8-7316F437F86E}"/>
              </pc2:cmMkLst>
            </pc226:cmChg>
          </p:ext>
        </pc:extLst>
      </pc:sldChg>
      <pc:sldChg chg="modSp mod">
        <pc:chgData name="WILTON MBINDA" userId="2ed3b63821f91397" providerId="LiveId" clId="{321BA248-EF86-438F-BB9D-92D1FC92C99F}" dt="2023-11-04T12:16:30.128" v="3" actId="13926"/>
        <pc:sldMkLst>
          <pc:docMk/>
          <pc:sldMk cId="1224104333" sldId="285"/>
        </pc:sldMkLst>
        <pc:spChg chg="mod">
          <ac:chgData name="WILTON MBINDA" userId="2ed3b63821f91397" providerId="LiveId" clId="{321BA248-EF86-438F-BB9D-92D1FC92C99F}" dt="2023-11-04T12:16:30.128" v="3" actId="13926"/>
          <ac:spMkLst>
            <pc:docMk/>
            <pc:sldMk cId="1224104333" sldId="285"/>
            <ac:spMk id="7" creationId="{00000000-0000-0000-0000-000000000000}"/>
          </ac:spMkLst>
        </pc:spChg>
      </pc:sldChg>
    </pc:docChg>
  </pc:docChgLst>
  <pc:docChgLst>
    <pc:chgData name="WILTON MBINDA" userId="2ed3b63821f91397" providerId="LiveId" clId="{D77A817A-B394-4F41-9872-0F5DCAC5A666}"/>
    <pc:docChg chg="undo custSel modSld">
      <pc:chgData name="WILTON MBINDA" userId="2ed3b63821f91397" providerId="LiveId" clId="{D77A817A-B394-4F41-9872-0F5DCAC5A666}" dt="2024-05-25T08:10:33.727" v="83" actId="113"/>
      <pc:docMkLst>
        <pc:docMk/>
      </pc:docMkLst>
      <pc:sldChg chg="modSp mod">
        <pc:chgData name="WILTON MBINDA" userId="2ed3b63821f91397" providerId="LiveId" clId="{D77A817A-B394-4F41-9872-0F5DCAC5A666}" dt="2024-05-25T08:09:48.056" v="71"/>
        <pc:sldMkLst>
          <pc:docMk/>
          <pc:sldMk cId="322960254" sldId="265"/>
        </pc:sldMkLst>
        <pc:spChg chg="mod">
          <ac:chgData name="WILTON MBINDA" userId="2ed3b63821f91397" providerId="LiveId" clId="{D77A817A-B394-4F41-9872-0F5DCAC5A666}" dt="2024-05-25T08:09:48.056" v="71"/>
          <ac:spMkLst>
            <pc:docMk/>
            <pc:sldMk cId="322960254" sldId="265"/>
            <ac:spMk id="12" creationId="{00000000-0000-0000-0000-000000000000}"/>
          </ac:spMkLst>
        </pc:spChg>
      </pc:sldChg>
      <pc:sldChg chg="modSp mod">
        <pc:chgData name="WILTON MBINDA" userId="2ed3b63821f91397" providerId="LiveId" clId="{D77A817A-B394-4F41-9872-0F5DCAC5A666}" dt="2024-05-25T08:09:40.943" v="69"/>
        <pc:sldMkLst>
          <pc:docMk/>
          <pc:sldMk cId="2923045384" sldId="268"/>
        </pc:sldMkLst>
        <pc:spChg chg="mod">
          <ac:chgData name="WILTON MBINDA" userId="2ed3b63821f91397" providerId="LiveId" clId="{D77A817A-B394-4F41-9872-0F5DCAC5A666}" dt="2024-05-25T08:09:40.943" v="69"/>
          <ac:spMkLst>
            <pc:docMk/>
            <pc:sldMk cId="2923045384" sldId="268"/>
            <ac:spMk id="5" creationId="{28F699B2-A32F-3FAB-A42C-E6480C680EA6}"/>
          </ac:spMkLst>
        </pc:spChg>
      </pc:sldChg>
      <pc:sldChg chg="modSp mod">
        <pc:chgData name="WILTON MBINDA" userId="2ed3b63821f91397" providerId="LiveId" clId="{D77A817A-B394-4F41-9872-0F5DCAC5A666}" dt="2024-05-25T08:09:36.625" v="68"/>
        <pc:sldMkLst>
          <pc:docMk/>
          <pc:sldMk cId="1608119596" sldId="271"/>
        </pc:sldMkLst>
        <pc:spChg chg="mod">
          <ac:chgData name="WILTON MBINDA" userId="2ed3b63821f91397" providerId="LiveId" clId="{D77A817A-B394-4F41-9872-0F5DCAC5A666}" dt="2024-05-25T08:09:36.625" v="68"/>
          <ac:spMkLst>
            <pc:docMk/>
            <pc:sldMk cId="1608119596" sldId="271"/>
            <ac:spMk id="3" creationId="{00000000-0000-0000-0000-000000000000}"/>
          </ac:spMkLst>
        </pc:spChg>
        <pc:grpChg chg="mod">
          <ac:chgData name="WILTON MBINDA" userId="2ed3b63821f91397" providerId="LiveId" clId="{D77A817A-B394-4F41-9872-0F5DCAC5A666}" dt="2024-05-25T08:08:18.397" v="48" actId="1076"/>
          <ac:grpSpMkLst>
            <pc:docMk/>
            <pc:sldMk cId="1608119596" sldId="271"/>
            <ac:grpSpMk id="4" creationId="{00000000-0000-0000-0000-000000000000}"/>
          </ac:grpSpMkLst>
        </pc:grpChg>
      </pc:sldChg>
      <pc:sldChg chg="modSp mod">
        <pc:chgData name="WILTON MBINDA" userId="2ed3b63821f91397" providerId="LiveId" clId="{D77A817A-B394-4F41-9872-0F5DCAC5A666}" dt="2024-05-25T08:09:31.645" v="67"/>
        <pc:sldMkLst>
          <pc:docMk/>
          <pc:sldMk cId="813699893" sldId="275"/>
        </pc:sldMkLst>
        <pc:spChg chg="mod">
          <ac:chgData name="WILTON MBINDA" userId="2ed3b63821f91397" providerId="LiveId" clId="{D77A817A-B394-4F41-9872-0F5DCAC5A666}" dt="2024-05-25T08:09:31.645" v="67"/>
          <ac:spMkLst>
            <pc:docMk/>
            <pc:sldMk cId="813699893" sldId="275"/>
            <ac:spMk id="3" creationId="{00000000-0000-0000-0000-000000000000}"/>
          </ac:spMkLst>
        </pc:spChg>
      </pc:sldChg>
      <pc:sldChg chg="modSp mod">
        <pc:chgData name="WILTON MBINDA" userId="2ed3b63821f91397" providerId="LiveId" clId="{D77A817A-B394-4F41-9872-0F5DCAC5A666}" dt="2024-05-25T08:09:24.261" v="65" actId="20577"/>
        <pc:sldMkLst>
          <pc:docMk/>
          <pc:sldMk cId="3113638548" sldId="276"/>
        </pc:sldMkLst>
        <pc:spChg chg="mod">
          <ac:chgData name="WILTON MBINDA" userId="2ed3b63821f91397" providerId="LiveId" clId="{D77A817A-B394-4F41-9872-0F5DCAC5A666}" dt="2024-05-25T08:09:24.261" v="65" actId="20577"/>
          <ac:spMkLst>
            <pc:docMk/>
            <pc:sldMk cId="3113638548" sldId="276"/>
            <ac:spMk id="3" creationId="{00000000-0000-0000-0000-000000000000}"/>
          </ac:spMkLst>
        </pc:spChg>
      </pc:sldChg>
      <pc:sldChg chg="modSp mod">
        <pc:chgData name="WILTON MBINDA" userId="2ed3b63821f91397" providerId="LiveId" clId="{D77A817A-B394-4F41-9872-0F5DCAC5A666}" dt="2024-05-25T08:09:53.599" v="73"/>
        <pc:sldMkLst>
          <pc:docMk/>
          <pc:sldMk cId="1224104333" sldId="285"/>
        </pc:sldMkLst>
        <pc:spChg chg="mod">
          <ac:chgData name="WILTON MBINDA" userId="2ed3b63821f91397" providerId="LiveId" clId="{D77A817A-B394-4F41-9872-0F5DCAC5A666}" dt="2024-05-25T08:09:53.599" v="73"/>
          <ac:spMkLst>
            <pc:docMk/>
            <pc:sldMk cId="1224104333" sldId="285"/>
            <ac:spMk id="7" creationId="{00000000-0000-0000-0000-000000000000}"/>
          </ac:spMkLst>
        </pc:spChg>
      </pc:sldChg>
      <pc:sldChg chg="modSp mod">
        <pc:chgData name="WILTON MBINDA" userId="2ed3b63821f91397" providerId="LiveId" clId="{D77A817A-B394-4F41-9872-0F5DCAC5A666}" dt="2024-05-25T08:10:33.727" v="83" actId="113"/>
        <pc:sldMkLst>
          <pc:docMk/>
          <pc:sldMk cId="1063070901" sldId="287"/>
        </pc:sldMkLst>
        <pc:spChg chg="mod">
          <ac:chgData name="WILTON MBINDA" userId="2ed3b63821f91397" providerId="LiveId" clId="{D77A817A-B394-4F41-9872-0F5DCAC5A666}" dt="2024-05-25T08:10:04.617" v="79" actId="20577"/>
          <ac:spMkLst>
            <pc:docMk/>
            <pc:sldMk cId="1063070901" sldId="287"/>
            <ac:spMk id="4" creationId="{00000000-0000-0000-0000-000000000000}"/>
          </ac:spMkLst>
        </pc:spChg>
        <pc:graphicFrameChg chg="mod modGraphic">
          <ac:chgData name="WILTON MBINDA" userId="2ed3b63821f91397" providerId="LiveId" clId="{D77A817A-B394-4F41-9872-0F5DCAC5A666}" dt="2024-05-25T08:10:33.727" v="83" actId="113"/>
          <ac:graphicFrameMkLst>
            <pc:docMk/>
            <pc:sldMk cId="1063070901" sldId="287"/>
            <ac:graphicFrameMk id="5" creationId="{00000000-0000-0000-0000-000000000000}"/>
          </ac:graphicFrameMkLst>
        </pc:graphicFrameChg>
      </pc:sldChg>
    </pc:docChg>
  </pc:docChgLst>
  <pc:docChgLst>
    <pc:chgData name="WILTON MBINDA" userId="2ed3b63821f91397" providerId="LiveId" clId="{262890E3-6BCC-4A05-8A35-17F6A4A4EC96}"/>
    <pc:docChg chg="undo custSel delSld modSld">
      <pc:chgData name="WILTON MBINDA" userId="2ed3b63821f91397" providerId="LiveId" clId="{262890E3-6BCC-4A05-8A35-17F6A4A4EC96}" dt="2024-02-18T14:48:43.253" v="11" actId="1076"/>
      <pc:docMkLst>
        <pc:docMk/>
      </pc:docMkLst>
      <pc:sldChg chg="modSp mod">
        <pc:chgData name="WILTON MBINDA" userId="2ed3b63821f91397" providerId="LiveId" clId="{262890E3-6BCC-4A05-8A35-17F6A4A4EC96}" dt="2024-02-18T14:48:34.743" v="10" actId="1076"/>
        <pc:sldMkLst>
          <pc:docMk/>
          <pc:sldMk cId="1224104333" sldId="285"/>
        </pc:sldMkLst>
        <pc:spChg chg="mod">
          <ac:chgData name="WILTON MBINDA" userId="2ed3b63821f91397" providerId="LiveId" clId="{262890E3-6BCC-4A05-8A35-17F6A4A4EC96}" dt="2024-02-18T14:48:34.743" v="10" actId="1076"/>
          <ac:spMkLst>
            <pc:docMk/>
            <pc:sldMk cId="1224104333" sldId="285"/>
            <ac:spMk id="7" creationId="{00000000-0000-0000-0000-000000000000}"/>
          </ac:spMkLst>
        </pc:spChg>
        <pc:grpChg chg="mod">
          <ac:chgData name="WILTON MBINDA" userId="2ed3b63821f91397" providerId="LiveId" clId="{262890E3-6BCC-4A05-8A35-17F6A4A4EC96}" dt="2024-02-18T14:48:34.111" v="9" actId="1076"/>
          <ac:grpSpMkLst>
            <pc:docMk/>
            <pc:sldMk cId="1224104333" sldId="285"/>
            <ac:grpSpMk id="3" creationId="{00000000-0000-0000-0000-000000000000}"/>
          </ac:grpSpMkLst>
        </pc:grpChg>
      </pc:sldChg>
      <pc:sldChg chg="del">
        <pc:chgData name="WILTON MBINDA" userId="2ed3b63821f91397" providerId="LiveId" clId="{262890E3-6BCC-4A05-8A35-17F6A4A4EC96}" dt="2024-02-18T14:48:07.568" v="1" actId="47"/>
        <pc:sldMkLst>
          <pc:docMk/>
          <pc:sldMk cId="3407617978" sldId="286"/>
        </pc:sldMkLst>
      </pc:sldChg>
      <pc:sldChg chg="modSp mod">
        <pc:chgData name="WILTON MBINDA" userId="2ed3b63821f91397" providerId="LiveId" clId="{262890E3-6BCC-4A05-8A35-17F6A4A4EC96}" dt="2024-02-18T14:48:43.253" v="11" actId="1076"/>
        <pc:sldMkLst>
          <pc:docMk/>
          <pc:sldMk cId="1063070901" sldId="287"/>
        </pc:sldMkLst>
        <pc:spChg chg="mod">
          <ac:chgData name="WILTON MBINDA" userId="2ed3b63821f91397" providerId="LiveId" clId="{262890E3-6BCC-4A05-8A35-17F6A4A4EC96}" dt="2024-02-18T14:47:59.929" v="0" actId="1076"/>
          <ac:spMkLst>
            <pc:docMk/>
            <pc:sldMk cId="1063070901" sldId="287"/>
            <ac:spMk id="4" creationId="{00000000-0000-0000-0000-000000000000}"/>
          </ac:spMkLst>
        </pc:spChg>
        <pc:graphicFrameChg chg="mod">
          <ac:chgData name="WILTON MBINDA" userId="2ed3b63821f91397" providerId="LiveId" clId="{262890E3-6BCC-4A05-8A35-17F6A4A4EC96}" dt="2024-02-18T14:48:43.253" v="11" actId="1076"/>
          <ac:graphicFrameMkLst>
            <pc:docMk/>
            <pc:sldMk cId="1063070901" sldId="287"/>
            <ac:graphicFrameMk id="5" creationId="{00000000-0000-0000-0000-000000000000}"/>
          </ac:graphicFrameMkLst>
        </pc:graphicFrameChg>
      </pc:sldChg>
    </pc:docChg>
  </pc:docChgLst>
  <pc:docChgLst>
    <pc:chgData name="WILTON MBINDA" userId="2ed3b63821f91397" providerId="LiveId" clId="{4A8DCB66-01E4-4C46-9915-0C3D05C13375}"/>
    <pc:docChg chg="undo custSel addSld delSld modSld sldOrd">
      <pc:chgData name="WILTON MBINDA" userId="2ed3b63821f91397" providerId="LiveId" clId="{4A8DCB66-01E4-4C46-9915-0C3D05C13375}" dt="2024-01-24T08:18:07.065" v="148" actId="1076"/>
      <pc:docMkLst>
        <pc:docMk/>
      </pc:docMkLst>
      <pc:sldChg chg="addSp delSp modSp add mod">
        <pc:chgData name="WILTON MBINDA" userId="2ed3b63821f91397" providerId="LiveId" clId="{4A8DCB66-01E4-4C46-9915-0C3D05C13375}" dt="2024-01-24T08:18:07.065" v="148" actId="1076"/>
        <pc:sldMkLst>
          <pc:docMk/>
          <pc:sldMk cId="2923045384" sldId="268"/>
        </pc:sldMkLst>
        <pc:spChg chg="del">
          <ac:chgData name="WILTON MBINDA" userId="2ed3b63821f91397" providerId="LiveId" clId="{4A8DCB66-01E4-4C46-9915-0C3D05C13375}" dt="2024-01-24T08:15:58.472" v="115" actId="478"/>
          <ac:spMkLst>
            <pc:docMk/>
            <pc:sldMk cId="2923045384" sldId="268"/>
            <ac:spMk id="3" creationId="{00000000-0000-0000-0000-000000000000}"/>
          </ac:spMkLst>
        </pc:spChg>
        <pc:spChg chg="add mod">
          <ac:chgData name="WILTON MBINDA" userId="2ed3b63821f91397" providerId="LiveId" clId="{4A8DCB66-01E4-4C46-9915-0C3D05C13375}" dt="2024-01-24T08:18:07.065" v="148" actId="1076"/>
          <ac:spMkLst>
            <pc:docMk/>
            <pc:sldMk cId="2923045384" sldId="268"/>
            <ac:spMk id="5" creationId="{28F699B2-A32F-3FAB-A42C-E6480C680EA6}"/>
          </ac:spMkLst>
        </pc:spChg>
        <pc:picChg chg="mod">
          <ac:chgData name="WILTON MBINDA" userId="2ed3b63821f91397" providerId="LiveId" clId="{4A8DCB66-01E4-4C46-9915-0C3D05C13375}" dt="2024-01-24T08:15:56.402" v="114" actId="1076"/>
          <ac:picMkLst>
            <pc:docMk/>
            <pc:sldMk cId="2923045384" sldId="268"/>
            <ac:picMk id="2" creationId="{00000000-0000-0000-0000-000000000000}"/>
          </ac:picMkLst>
        </pc:picChg>
      </pc:sldChg>
      <pc:sldChg chg="addSp delSp modSp add del mod">
        <pc:chgData name="WILTON MBINDA" userId="2ed3b63821f91397" providerId="LiveId" clId="{4A8DCB66-01E4-4C46-9915-0C3D05C13375}" dt="2024-01-24T08:15:34.159" v="107" actId="47"/>
        <pc:sldMkLst>
          <pc:docMk/>
          <pc:sldMk cId="2892551273" sldId="270"/>
        </pc:sldMkLst>
        <pc:spChg chg="mod">
          <ac:chgData name="WILTON MBINDA" userId="2ed3b63821f91397" providerId="LiveId" clId="{4A8DCB66-01E4-4C46-9915-0C3D05C13375}" dt="2024-01-24T08:12:55.945" v="101" actId="1076"/>
          <ac:spMkLst>
            <pc:docMk/>
            <pc:sldMk cId="2892551273" sldId="270"/>
            <ac:spMk id="7" creationId="{00000000-0000-0000-0000-000000000000}"/>
          </ac:spMkLst>
        </pc:spChg>
        <pc:grpChg chg="del">
          <ac:chgData name="WILTON MBINDA" userId="2ed3b63821f91397" providerId="LiveId" clId="{4A8DCB66-01E4-4C46-9915-0C3D05C13375}" dt="2024-01-24T08:00:41.237" v="62" actId="478"/>
          <ac:grpSpMkLst>
            <pc:docMk/>
            <pc:sldMk cId="2892551273" sldId="270"/>
            <ac:grpSpMk id="2" creationId="{00000000-0000-0000-0000-000000000000}"/>
          </ac:grpSpMkLst>
        </pc:grpChg>
        <pc:picChg chg="add mod">
          <ac:chgData name="WILTON MBINDA" userId="2ed3b63821f91397" providerId="LiveId" clId="{4A8DCB66-01E4-4C46-9915-0C3D05C13375}" dt="2024-01-24T08:00:50.638" v="65" actId="1076"/>
          <ac:picMkLst>
            <pc:docMk/>
            <pc:sldMk cId="2892551273" sldId="270"/>
            <ac:picMk id="8" creationId="{3B644EC9-5CA7-BBCF-56D9-AC916B801BA1}"/>
          </ac:picMkLst>
        </pc:picChg>
      </pc:sldChg>
      <pc:sldChg chg="modSp mod">
        <pc:chgData name="WILTON MBINDA" userId="2ed3b63821f91397" providerId="LiveId" clId="{4A8DCB66-01E4-4C46-9915-0C3D05C13375}" dt="2024-01-24T08:03:03.252" v="100" actId="14100"/>
        <pc:sldMkLst>
          <pc:docMk/>
          <pc:sldMk cId="1608119596" sldId="271"/>
        </pc:sldMkLst>
        <pc:spChg chg="mod">
          <ac:chgData name="WILTON MBINDA" userId="2ed3b63821f91397" providerId="LiveId" clId="{4A8DCB66-01E4-4C46-9915-0C3D05C13375}" dt="2024-01-24T08:03:03.252" v="100" actId="14100"/>
          <ac:spMkLst>
            <pc:docMk/>
            <pc:sldMk cId="1608119596" sldId="271"/>
            <ac:spMk id="3" creationId="{00000000-0000-0000-0000-000000000000}"/>
          </ac:spMkLst>
        </pc:spChg>
      </pc:sldChg>
      <pc:sldChg chg="ord">
        <pc:chgData name="WILTON MBINDA" userId="2ed3b63821f91397" providerId="LiveId" clId="{4A8DCB66-01E4-4C46-9915-0C3D05C13375}" dt="2024-01-24T07:52:56.909" v="2"/>
        <pc:sldMkLst>
          <pc:docMk/>
          <pc:sldMk cId="1224104333" sldId="285"/>
        </pc:sldMkLst>
      </pc:sldChg>
      <pc:sldChg chg="addSp modSp new mod">
        <pc:chgData name="WILTON MBINDA" userId="2ed3b63821f91397" providerId="LiveId" clId="{4A8DCB66-01E4-4C46-9915-0C3D05C13375}" dt="2024-01-24T07:53:39.647" v="24" actId="20577"/>
        <pc:sldMkLst>
          <pc:docMk/>
          <pc:sldMk cId="3407617978" sldId="286"/>
        </pc:sldMkLst>
        <pc:spChg chg="add mod">
          <ac:chgData name="WILTON MBINDA" userId="2ed3b63821f91397" providerId="LiveId" clId="{4A8DCB66-01E4-4C46-9915-0C3D05C13375}" dt="2024-01-24T07:53:39.647" v="24" actId="20577"/>
          <ac:spMkLst>
            <pc:docMk/>
            <pc:sldMk cId="3407617978" sldId="286"/>
            <ac:spMk id="3" creationId="{69378B64-8876-7C51-BB58-67C7012766D0}"/>
          </ac:spMkLst>
        </pc:spChg>
      </pc:sldChg>
      <pc:sldChg chg="addSp modSp new mod">
        <pc:chgData name="WILTON MBINDA" userId="2ed3b63821f91397" providerId="LiveId" clId="{4A8DCB66-01E4-4C46-9915-0C3D05C13375}" dt="2024-01-24T07:56:43.196" v="59" actId="20577"/>
        <pc:sldMkLst>
          <pc:docMk/>
          <pc:sldMk cId="1063070901" sldId="287"/>
        </pc:sldMkLst>
        <pc:spChg chg="add mod">
          <ac:chgData name="WILTON MBINDA" userId="2ed3b63821f91397" providerId="LiveId" clId="{4A8DCB66-01E4-4C46-9915-0C3D05C13375}" dt="2024-01-24T07:56:43.196" v="59" actId="20577"/>
          <ac:spMkLst>
            <pc:docMk/>
            <pc:sldMk cId="1063070901" sldId="287"/>
            <ac:spMk id="3" creationId="{3BEEB6E9-9F08-953C-6E79-622CDA564364}"/>
          </ac:spMkLst>
        </pc:spChg>
      </pc:sldChg>
      <pc:sldChg chg="new del">
        <pc:chgData name="WILTON MBINDA" userId="2ed3b63821f91397" providerId="LiveId" clId="{4A8DCB66-01E4-4C46-9915-0C3D05C13375}" dt="2024-01-24T07:57:52.916" v="61" actId="47"/>
        <pc:sldMkLst>
          <pc:docMk/>
          <pc:sldMk cId="865915637" sldId="288"/>
        </pc:sldMkLst>
      </pc:sldChg>
      <pc:sldChg chg="new del">
        <pc:chgData name="WILTON MBINDA" userId="2ed3b63821f91397" providerId="LiveId" clId="{4A8DCB66-01E4-4C46-9915-0C3D05C13375}" dt="2024-01-24T08:14:41.841" v="104" actId="47"/>
        <pc:sldMkLst>
          <pc:docMk/>
          <pc:sldMk cId="926007236" sldId="28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BD1E36-91FE-449F-A4B0-A5CC3F08368E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506C0-AC54-465F-B87A-64EF00DDF4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5554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BD1E36-91FE-449F-A4B0-A5CC3F08368E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506C0-AC54-465F-B87A-64EF00DDF4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7081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BD1E36-91FE-449F-A4B0-A5CC3F08368E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506C0-AC54-465F-B87A-64EF00DDF4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4839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BD1E36-91FE-449F-A4B0-A5CC3F08368E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506C0-AC54-465F-B87A-64EF00DDF4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7451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BD1E36-91FE-449F-A4B0-A5CC3F08368E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506C0-AC54-465F-B87A-64EF00DDF4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7704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BD1E36-91FE-449F-A4B0-A5CC3F08368E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506C0-AC54-465F-B87A-64EF00DDF4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6171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BD1E36-91FE-449F-A4B0-A5CC3F08368E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506C0-AC54-465F-B87A-64EF00DDF4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2986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BD1E36-91FE-449F-A4B0-A5CC3F08368E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506C0-AC54-465F-B87A-64EF00DDF4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7560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BD1E36-91FE-449F-A4B0-A5CC3F08368E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506C0-AC54-465F-B87A-64EF00DDF4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2522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BD1E36-91FE-449F-A4B0-A5CC3F08368E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506C0-AC54-465F-B87A-64EF00DDF4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1490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BD1E36-91FE-449F-A4B0-A5CC3F08368E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506C0-AC54-465F-B87A-64EF00DDF4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9013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BD1E36-91FE-449F-A4B0-A5CC3F08368E}" type="datetimeFigureOut">
              <a:rPr lang="en-GB" smtClean="0"/>
              <a:t>06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9506C0-AC54-465F-B87A-64EF00DDF4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4508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253066" y="1449327"/>
            <a:ext cx="10249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1 Table</a:t>
            </a:r>
            <a:endParaRPr lang="en-GB" b="1" dirty="0">
              <a:solidFill>
                <a:schemeClr val="tx1">
                  <a:lumMod val="95000"/>
                  <a:lumOff val="5000"/>
                </a:schemeClr>
              </a:solidFill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9436084"/>
              </p:ext>
            </p:extLst>
          </p:nvPr>
        </p:nvGraphicFramePr>
        <p:xfrm>
          <a:off x="1253065" y="2003383"/>
          <a:ext cx="9709795" cy="142561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75168">
                  <a:extLst>
                    <a:ext uri="{9D8B030D-6E8A-4147-A177-3AD203B41FA5}">
                      <a16:colId xmlns:a16="http://schemas.microsoft.com/office/drawing/2014/main" val="4205858339"/>
                    </a:ext>
                  </a:extLst>
                </a:gridCol>
                <a:gridCol w="3824697">
                  <a:extLst>
                    <a:ext uri="{9D8B030D-6E8A-4147-A177-3AD203B41FA5}">
                      <a16:colId xmlns:a16="http://schemas.microsoft.com/office/drawing/2014/main" val="1886629255"/>
                    </a:ext>
                  </a:extLst>
                </a:gridCol>
                <a:gridCol w="4909930">
                  <a:extLst>
                    <a:ext uri="{9D8B030D-6E8A-4147-A177-3AD203B41FA5}">
                      <a16:colId xmlns:a16="http://schemas.microsoft.com/office/drawing/2014/main" val="288326992"/>
                    </a:ext>
                  </a:extLst>
                </a:gridCol>
              </a:tblGrid>
              <a:tr h="536431">
                <a:tc>
                  <a:txBody>
                    <a:bodyPr/>
                    <a:lstStyle/>
                    <a:p>
                      <a:r>
                        <a:rPr lang="en-GB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S (ITS1-IST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S rRNA( NL1 – NL4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6326358"/>
                  </a:ext>
                </a:extLst>
              </a:tr>
              <a:tr h="444593">
                <a:tc>
                  <a:txBody>
                    <a:bodyPr/>
                    <a:lstStyle/>
                    <a:p>
                      <a:r>
                        <a:rPr lang="en-GB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/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’-TCCGTCGGTGAACCTGCGG-3’</a:t>
                      </a:r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’- GCATATCAATAAGCGGAGGAAAAG -3’</a:t>
                      </a:r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9859895"/>
                  </a:ext>
                </a:extLst>
              </a:tr>
              <a:tr h="444593">
                <a:tc>
                  <a:txBody>
                    <a:bodyPr/>
                    <a:lstStyle/>
                    <a:p>
                      <a:r>
                        <a:rPr lang="en-GB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/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’-TCCTCCGCTTATTGATATGC-3’</a:t>
                      </a:r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8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’- GGTCCGTGTTTCAAGACGG -3’</a:t>
                      </a:r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9016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630709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671031" y="296343"/>
            <a:ext cx="11151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 </a:t>
            </a: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</a:rPr>
              <a:t>Fig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718456" y="858036"/>
            <a:ext cx="10981510" cy="3966270"/>
            <a:chOff x="718456" y="858036"/>
            <a:chExt cx="10981510" cy="396627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86245" y="1058091"/>
              <a:ext cx="4572000" cy="3657600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718456" y="858036"/>
              <a:ext cx="53557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718663" y="1058091"/>
              <a:ext cx="41801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127966" y="1166706"/>
              <a:ext cx="4572000" cy="36576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241043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621510" y="1947163"/>
            <a:ext cx="7344941" cy="2711278"/>
            <a:chOff x="756706" y="42959"/>
            <a:chExt cx="8800993" cy="3436678"/>
          </a:xfrm>
        </p:grpSpPr>
        <p:grpSp>
          <p:nvGrpSpPr>
            <p:cNvPr id="3" name="Group 2"/>
            <p:cNvGrpSpPr/>
            <p:nvPr/>
          </p:nvGrpSpPr>
          <p:grpSpPr>
            <a:xfrm>
              <a:off x="756706" y="165080"/>
              <a:ext cx="8800993" cy="3314557"/>
              <a:chOff x="456590" y="122035"/>
              <a:chExt cx="8800993" cy="3314557"/>
            </a:xfrm>
          </p:grpSpPr>
          <p:pic>
            <p:nvPicPr>
              <p:cNvPr id="8" name="Picture 7"/>
              <p:cNvPicPr/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333"/>
              <a:stretch/>
            </p:blipFill>
            <p:spPr bwMode="auto">
              <a:xfrm>
                <a:off x="456590" y="196592"/>
                <a:ext cx="4050000" cy="3240000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10" name="Picture 9"/>
              <p:cNvPicPr/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812"/>
              <a:stretch/>
            </p:blipFill>
            <p:spPr bwMode="auto">
              <a:xfrm>
                <a:off x="5207583" y="122035"/>
                <a:ext cx="4050000" cy="3239769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</p:grpSp>
        <p:sp>
          <p:nvSpPr>
            <p:cNvPr id="6" name="TextBox 5"/>
            <p:cNvSpPr txBox="1"/>
            <p:nvPr/>
          </p:nvSpPr>
          <p:spPr>
            <a:xfrm>
              <a:off x="756706" y="42959"/>
              <a:ext cx="379918" cy="5071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  <p:sp>
        <p:nvSpPr>
          <p:cNvPr id="12" name="Rectangle 11"/>
          <p:cNvSpPr/>
          <p:nvPr/>
        </p:nvSpPr>
        <p:spPr>
          <a:xfrm>
            <a:off x="966075" y="548421"/>
            <a:ext cx="1007079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</a:rPr>
              <a:t>S5 Fig</a:t>
            </a:r>
            <a:endParaRPr lang="en-GB" dirty="0"/>
          </a:p>
        </p:txBody>
      </p:sp>
      <p:sp>
        <p:nvSpPr>
          <p:cNvPr id="14" name="TextBox 13"/>
          <p:cNvSpPr txBox="1"/>
          <p:nvPr/>
        </p:nvSpPr>
        <p:spPr>
          <a:xfrm>
            <a:off x="6586490" y="1902272"/>
            <a:ext cx="364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229602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6000" y="720807"/>
            <a:ext cx="5400000" cy="4320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8F699B2-A32F-3FAB-A42C-E6480C680EA6}"/>
              </a:ext>
            </a:extLst>
          </p:cNvPr>
          <p:cNvSpPr txBox="1"/>
          <p:nvPr/>
        </p:nvSpPr>
        <p:spPr>
          <a:xfrm>
            <a:off x="593861" y="265029"/>
            <a:ext cx="1046839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8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6</a:t>
            </a: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</a:rPr>
              <a:t> Fig</a:t>
            </a:r>
            <a:endParaRPr lang="en-GB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30453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87018" y="352741"/>
            <a:ext cx="1054191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7</a:t>
            </a: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</a:rPr>
              <a:t> Fig</a:t>
            </a:r>
            <a:endParaRPr lang="en-GB" i="1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790562" y="1267298"/>
            <a:ext cx="10800000" cy="4464000"/>
            <a:chOff x="0" y="1056305"/>
            <a:chExt cx="12115846" cy="451501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715"/>
            <a:stretch/>
          </p:blipFill>
          <p:spPr>
            <a:xfrm>
              <a:off x="0" y="1306285"/>
              <a:ext cx="6400847" cy="4265038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142"/>
            <a:stretch/>
          </p:blipFill>
          <p:spPr>
            <a:xfrm>
              <a:off x="6400847" y="1306285"/>
              <a:ext cx="5714999" cy="4199724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300446" y="1056305"/>
              <a:ext cx="365760" cy="4046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929893" y="1056305"/>
              <a:ext cx="248194" cy="4046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081195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082" y="1453832"/>
            <a:ext cx="9601835" cy="3950335"/>
          </a:xfrm>
          <a:prstGeom prst="rect">
            <a:avLst/>
          </a:prstGeom>
          <a:noFill/>
        </p:spPr>
      </p:pic>
      <p:sp>
        <p:nvSpPr>
          <p:cNvPr id="3" name="Rectangle 2"/>
          <p:cNvSpPr/>
          <p:nvPr/>
        </p:nvSpPr>
        <p:spPr>
          <a:xfrm>
            <a:off x="883919" y="409044"/>
            <a:ext cx="1042415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8 </a:t>
            </a: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</a:rPr>
              <a:t>Fig</a:t>
            </a:r>
            <a:endParaRPr lang="en-GB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36998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3700" y="1530032"/>
            <a:ext cx="8864600" cy="3797935"/>
          </a:xfrm>
          <a:prstGeom prst="rect">
            <a:avLst/>
          </a:prstGeom>
          <a:noFill/>
        </p:spPr>
      </p:pic>
      <p:sp>
        <p:nvSpPr>
          <p:cNvPr id="3" name="Rectangle 2"/>
          <p:cNvSpPr/>
          <p:nvPr/>
        </p:nvSpPr>
        <p:spPr>
          <a:xfrm>
            <a:off x="1036502" y="562555"/>
            <a:ext cx="1011899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</a:rPr>
              <a:t>S9 Fig</a:t>
            </a:r>
            <a:endParaRPr lang="en-GB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36385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58</TotalTime>
  <Words>58</Words>
  <Application>Microsoft Office PowerPoint</Application>
  <PresentationFormat>Widescreen</PresentationFormat>
  <Paragraphs>2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NNIS MUKHEBI</dc:creator>
  <cp:lastModifiedBy>WILTON MBINDA</cp:lastModifiedBy>
  <cp:revision>176</cp:revision>
  <dcterms:created xsi:type="dcterms:W3CDTF">2023-10-17T14:54:10Z</dcterms:created>
  <dcterms:modified xsi:type="dcterms:W3CDTF">2024-06-06T08:49:43Z</dcterms:modified>
</cp:coreProperties>
</file>